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88A6B9-0601-4407-B4F7-8AA975682EA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B8754A-EDF6-4C19-B22A-92AFA189FF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466156-D80D-4FAB-8848-C882F9E7DB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D761B-3999-4FEF-BBD0-F281C97A2C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F5C728-C3F8-48C5-B6A6-E452171DEB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13EA0-FFC4-4EAB-BAF3-99D78E6783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C91CF0-CB04-4811-9C05-A4140522FD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5552D-1932-4802-B5B6-828D3B60A0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D93CD-19AF-43DF-B231-4E02609193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5C806-4971-41CC-B499-0D9E081B21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E5090C-8FF2-49B2-893D-958782037F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9C7B01-B1CB-475F-A679-CD932096E3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A5CD78-F4CA-47CE-B499-CE176B1B75B5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Grafik 8" descr=""/>
          <p:cNvPicPr/>
          <p:nvPr/>
        </p:nvPicPr>
        <p:blipFill>
          <a:blip r:embed="rId1"/>
          <a:stretch/>
        </p:blipFill>
        <p:spPr>
          <a:xfrm>
            <a:off x="1440000" y="1440000"/>
            <a:ext cx="9242280" cy="414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Grafik 10" descr=""/>
          <p:cNvPicPr/>
          <p:nvPr/>
        </p:nvPicPr>
        <p:blipFill>
          <a:blip r:embed="rId1"/>
          <a:stretch/>
        </p:blipFill>
        <p:spPr>
          <a:xfrm>
            <a:off x="1477800" y="1308240"/>
            <a:ext cx="9236160" cy="4241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Grafik 8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Grafik 4" descr=""/>
          <p:cNvPicPr/>
          <p:nvPr/>
        </p:nvPicPr>
        <p:blipFill>
          <a:blip r:embed="rId1"/>
          <a:stretch/>
        </p:blipFill>
        <p:spPr>
          <a:xfrm>
            <a:off x="1569960" y="1157400"/>
            <a:ext cx="9051840" cy="4543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Grafik 7" descr=""/>
          <p:cNvPicPr/>
          <p:nvPr/>
        </p:nvPicPr>
        <p:blipFill>
          <a:blip r:embed="rId1"/>
          <a:stretch/>
        </p:blipFill>
        <p:spPr>
          <a:xfrm>
            <a:off x="1459080" y="1222200"/>
            <a:ext cx="92739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Grafik 8" descr=""/>
          <p:cNvPicPr/>
          <p:nvPr/>
        </p:nvPicPr>
        <p:blipFill>
          <a:blip r:embed="rId1"/>
          <a:stretch/>
        </p:blipFill>
        <p:spPr>
          <a:xfrm>
            <a:off x="1440000" y="1440000"/>
            <a:ext cx="9235800" cy="4413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Grafik 6" descr=""/>
          <p:cNvPicPr/>
          <p:nvPr/>
        </p:nvPicPr>
        <p:blipFill>
          <a:blip r:embed="rId1"/>
          <a:stretch/>
        </p:blipFill>
        <p:spPr>
          <a:xfrm>
            <a:off x="1514520" y="1222200"/>
            <a:ext cx="916308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Grafik 8" descr=""/>
          <p:cNvPicPr/>
          <p:nvPr/>
        </p:nvPicPr>
        <p:blipFill>
          <a:blip r:embed="rId1"/>
          <a:stretch/>
        </p:blipFill>
        <p:spPr>
          <a:xfrm>
            <a:off x="1440000" y="1222200"/>
            <a:ext cx="923580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Grafik 7" descr=""/>
          <p:cNvPicPr/>
          <p:nvPr/>
        </p:nvPicPr>
        <p:blipFill>
          <a:blip r:embed="rId1"/>
          <a:stretch/>
        </p:blipFill>
        <p:spPr>
          <a:xfrm>
            <a:off x="1569960" y="1222200"/>
            <a:ext cx="905184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Grafik 12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Grafik 7" descr=""/>
          <p:cNvPicPr/>
          <p:nvPr/>
        </p:nvPicPr>
        <p:blipFill>
          <a:blip r:embed="rId1"/>
          <a:stretch/>
        </p:blipFill>
        <p:spPr>
          <a:xfrm>
            <a:off x="1477800" y="1222200"/>
            <a:ext cx="9236160" cy="441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5T09:57:05Z</dcterms:created>
  <dc:creator>molenaar</dc:creator>
  <dc:description/>
  <dc:language>en-US</dc:language>
  <cp:lastModifiedBy>molenaar</cp:lastModifiedBy>
  <dcterms:modified xsi:type="dcterms:W3CDTF">2017-02-22T12:19:48Z</dcterms:modified>
  <cp:revision>9</cp:revision>
  <dc:subject/>
  <dc:title>PowerPoint-Präsentation</dc:title>
</cp:coreProperties>
</file>